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F0C28-BF5D-4461-B244-232628EC09D9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BD398-C4E0-40E4-906E-BE91F9859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71495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F0C28-BF5D-4461-B244-232628EC09D9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BD398-C4E0-40E4-906E-BE91F9859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1537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F0C28-BF5D-4461-B244-232628EC09D9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BD398-C4E0-40E4-906E-BE91F9859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0050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F0C28-BF5D-4461-B244-232628EC09D9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BD398-C4E0-40E4-906E-BE91F9859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8092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F0C28-BF5D-4461-B244-232628EC09D9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BD398-C4E0-40E4-906E-BE91F9859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94443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F0C28-BF5D-4461-B244-232628EC09D9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BD398-C4E0-40E4-906E-BE91F9859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68592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F0C28-BF5D-4461-B244-232628EC09D9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BD398-C4E0-40E4-906E-BE91F9859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42604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F0C28-BF5D-4461-B244-232628EC09D9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BD398-C4E0-40E4-906E-BE91F9859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09385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F0C28-BF5D-4461-B244-232628EC09D9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BD398-C4E0-40E4-906E-BE91F9859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79155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F0C28-BF5D-4461-B244-232628EC09D9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BD398-C4E0-40E4-906E-BE91F9859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97535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F0C28-BF5D-4461-B244-232628EC09D9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6BD398-C4E0-40E4-906E-BE91F9859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81435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5F0C28-BF5D-4461-B244-232628EC09D9}" type="datetimeFigureOut">
              <a:rPr lang="en-US" smtClean="0"/>
              <a:t>9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6BD398-C4E0-40E4-906E-BE91F98593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09201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939798" y="694787"/>
            <a:ext cx="387772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 Table 1. Variables description</a:t>
            </a:r>
            <a:endParaRPr lang="en-US" sz="1600" b="1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graphicFrame>
        <p:nvGraphicFramePr>
          <p:cNvPr id="3" name="Table 5">
            <a:extLst>
              <a:ext uri="{FF2B5EF4-FFF2-40B4-BE49-F238E27FC236}">
                <a16:creationId xmlns:a16="http://schemas.microsoft.com/office/drawing/2014/main" id="{AE463935-502C-4C62-AF83-7EECBC8E71DF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939798" y="1125220"/>
          <a:ext cx="8128000" cy="46075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09362">
                  <a:extLst>
                    <a:ext uri="{9D8B030D-6E8A-4147-A177-3AD203B41FA5}">
                      <a16:colId xmlns:a16="http://schemas.microsoft.com/office/drawing/2014/main" val="2718888583"/>
                    </a:ext>
                  </a:extLst>
                </a:gridCol>
                <a:gridCol w="666428">
                  <a:extLst>
                    <a:ext uri="{9D8B030D-6E8A-4147-A177-3AD203B41FA5}">
                      <a16:colId xmlns:a16="http://schemas.microsoft.com/office/drawing/2014/main" val="4069419722"/>
                    </a:ext>
                  </a:extLst>
                </a:gridCol>
                <a:gridCol w="1099951">
                  <a:extLst>
                    <a:ext uri="{9D8B030D-6E8A-4147-A177-3AD203B41FA5}">
                      <a16:colId xmlns:a16="http://schemas.microsoft.com/office/drawing/2014/main" val="1114730205"/>
                    </a:ext>
                  </a:extLst>
                </a:gridCol>
                <a:gridCol w="3735092">
                  <a:extLst>
                    <a:ext uri="{9D8B030D-6E8A-4147-A177-3AD203B41FA5}">
                      <a16:colId xmlns:a16="http://schemas.microsoft.com/office/drawing/2014/main" val="2502330548"/>
                    </a:ext>
                  </a:extLst>
                </a:gridCol>
                <a:gridCol w="1117167">
                  <a:extLst>
                    <a:ext uri="{9D8B030D-6E8A-4147-A177-3AD203B41FA5}">
                      <a16:colId xmlns:a16="http://schemas.microsoft.com/office/drawing/2014/main" val="3947035380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riable nam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riable typ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scrip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i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04072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ngue outbreak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rge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nar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ccurrence of dengue fever outbreak</a:t>
                      </a:r>
                    </a:p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= Outbreak will occur</a:t>
                      </a:r>
                    </a:p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 =Outbreak will not occu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0643832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tric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pu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egorica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trict of the dengue fever cases occurre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9435326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Rainfal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put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inuou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 weekly rainfall amoun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llimeter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956933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Temperatur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put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inuou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 weekly temperatur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°C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723906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imum temperatur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put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inuou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imum weekly temperatur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°C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7586155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nimum temperatur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put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inuou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nimum weekly temperatur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°C</a:t>
                      </a:r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7788744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humidit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put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inuou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 weekly relative humidit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am/ Kilogram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9621717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win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put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inuou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 weekly wind spee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er/ Second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5554922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a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pu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egorica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ar of the dengue fever incidence occurre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3849487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ek of yea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pu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egorica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ek of year which the dengue fever incidence occurre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937910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286148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/>
          </p:nvPr>
        </p:nvGraphicFramePr>
        <p:xfrm>
          <a:off x="1598247" y="2038855"/>
          <a:ext cx="6786336" cy="2323917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478167">
                  <a:extLst>
                    <a:ext uri="{9D8B030D-6E8A-4147-A177-3AD203B41FA5}">
                      <a16:colId xmlns:a16="http://schemas.microsoft.com/office/drawing/2014/main" val="318048889"/>
                    </a:ext>
                  </a:extLst>
                </a:gridCol>
                <a:gridCol w="1038386">
                  <a:extLst>
                    <a:ext uri="{9D8B030D-6E8A-4147-A177-3AD203B41FA5}">
                      <a16:colId xmlns:a16="http://schemas.microsoft.com/office/drawing/2014/main" val="1603146774"/>
                    </a:ext>
                  </a:extLst>
                </a:gridCol>
                <a:gridCol w="2549471">
                  <a:extLst>
                    <a:ext uri="{9D8B030D-6E8A-4147-A177-3AD203B41FA5}">
                      <a16:colId xmlns:a16="http://schemas.microsoft.com/office/drawing/2014/main" val="2652721095"/>
                    </a:ext>
                  </a:extLst>
                </a:gridCol>
                <a:gridCol w="1720312">
                  <a:extLst>
                    <a:ext uri="{9D8B030D-6E8A-4147-A177-3AD203B41FA5}">
                      <a16:colId xmlns:a16="http://schemas.microsoft.com/office/drawing/2014/main" val="3501948479"/>
                    </a:ext>
                  </a:extLst>
                </a:gridCol>
              </a:tblGrid>
              <a:tr h="258213"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riable 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yp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scription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ge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257510517"/>
                  </a:ext>
                </a:extLst>
              </a:tr>
              <a:tr h="258213"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ar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minal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ar of the recorded data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3 - 2017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13834533"/>
                  </a:ext>
                </a:extLst>
              </a:tr>
              <a:tr h="258213"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nth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minal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nth of the recorded data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- 12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901416301"/>
                  </a:ext>
                </a:extLst>
              </a:tr>
              <a:tr h="258213"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minal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 of the recorded data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- 31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07850270"/>
                  </a:ext>
                </a:extLst>
              </a:tr>
              <a:tr h="258213"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tion number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minal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tion where the data was recorded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715205724"/>
                  </a:ext>
                </a:extLst>
              </a:tr>
              <a:tr h="258213"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infall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inuou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ily Rainfall amount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 - 175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97293813"/>
                  </a:ext>
                </a:extLst>
              </a:tr>
              <a:tr h="258213"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mperature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inuou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ily temperature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5 - 31.5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87627062"/>
                  </a:ext>
                </a:extLst>
              </a:tr>
              <a:tr h="258213"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umidity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inuou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ily relative humidity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.0 - 99.6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722660498"/>
                  </a:ext>
                </a:extLst>
              </a:tr>
              <a:tr h="258213"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nd Speed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inuou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ily wind speed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17145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 - 32.7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32182589"/>
                  </a:ext>
                </a:extLst>
              </a:tr>
            </a:tbl>
          </a:graphicData>
        </a:graphic>
      </p:graphicFrame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1598247" y="1601841"/>
            <a:ext cx="5871936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Table 2. Description of dataset variable</a:t>
            </a:r>
            <a:endParaRPr kumimoji="0" lang="en-US" altLang="en-US" sz="1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643243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84D59049-CBC1-4EC4-9F2C-52765209D101}"/>
              </a:ext>
            </a:extLst>
          </p:cNvPr>
          <p:cNvSpPr/>
          <p:nvPr/>
        </p:nvSpPr>
        <p:spPr>
          <a:xfrm>
            <a:off x="1428426" y="1085923"/>
            <a:ext cx="7746569" cy="4174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 Table 3. Excel table in generating outbreak variable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F27D459-09F5-4AD4-AE44-E0CC3B683596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19438" y="1525009"/>
            <a:ext cx="7199689" cy="2834555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6458452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1">
            <a:extLst>
              <a:ext uri="{FF2B5EF4-FFF2-40B4-BE49-F238E27FC236}">
                <a16:creationId xmlns:a16="http://schemas.microsoft.com/office/drawing/2014/main" id="{9BDD0292-770C-44FE-8440-25C702EFF6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66942" y="1222629"/>
            <a:ext cx="6287747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Table 4. Dengue fever outbreak cases by district and year</a:t>
            </a:r>
            <a:endParaRPr kumimoji="0" lang="en-US" altLang="en-US" sz="1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0361C44C-F2D7-43DF-BA97-6BAA7C381C8B}"/>
              </a:ext>
            </a:extLst>
          </p:cNvPr>
          <p:cNvGraphicFramePr>
            <a:graphicFrameLocks noGrp="1"/>
          </p:cNvGraphicFramePr>
          <p:nvPr/>
        </p:nvGraphicFramePr>
        <p:xfrm>
          <a:off x="2066942" y="1671999"/>
          <a:ext cx="7092555" cy="4566066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080295">
                  <a:extLst>
                    <a:ext uri="{9D8B030D-6E8A-4147-A177-3AD203B41FA5}">
                      <a16:colId xmlns:a16="http://schemas.microsoft.com/office/drawing/2014/main" val="3872160679"/>
                    </a:ext>
                  </a:extLst>
                </a:gridCol>
                <a:gridCol w="837692">
                  <a:extLst>
                    <a:ext uri="{9D8B030D-6E8A-4147-A177-3AD203B41FA5}">
                      <a16:colId xmlns:a16="http://schemas.microsoft.com/office/drawing/2014/main" val="3534459419"/>
                    </a:ext>
                  </a:extLst>
                </a:gridCol>
                <a:gridCol w="739224">
                  <a:extLst>
                    <a:ext uri="{9D8B030D-6E8A-4147-A177-3AD203B41FA5}">
                      <a16:colId xmlns:a16="http://schemas.microsoft.com/office/drawing/2014/main" val="1755260789"/>
                    </a:ext>
                  </a:extLst>
                </a:gridCol>
                <a:gridCol w="739224">
                  <a:extLst>
                    <a:ext uri="{9D8B030D-6E8A-4147-A177-3AD203B41FA5}">
                      <a16:colId xmlns:a16="http://schemas.microsoft.com/office/drawing/2014/main" val="3169828872"/>
                    </a:ext>
                  </a:extLst>
                </a:gridCol>
                <a:gridCol w="739224">
                  <a:extLst>
                    <a:ext uri="{9D8B030D-6E8A-4147-A177-3AD203B41FA5}">
                      <a16:colId xmlns:a16="http://schemas.microsoft.com/office/drawing/2014/main" val="4021658175"/>
                    </a:ext>
                  </a:extLst>
                </a:gridCol>
                <a:gridCol w="739224">
                  <a:extLst>
                    <a:ext uri="{9D8B030D-6E8A-4147-A177-3AD203B41FA5}">
                      <a16:colId xmlns:a16="http://schemas.microsoft.com/office/drawing/2014/main" val="1372900909"/>
                    </a:ext>
                  </a:extLst>
                </a:gridCol>
                <a:gridCol w="739224">
                  <a:extLst>
                    <a:ext uri="{9D8B030D-6E8A-4147-A177-3AD203B41FA5}">
                      <a16:colId xmlns:a16="http://schemas.microsoft.com/office/drawing/2014/main" val="14752233"/>
                    </a:ext>
                  </a:extLst>
                </a:gridCol>
                <a:gridCol w="739224">
                  <a:extLst>
                    <a:ext uri="{9D8B030D-6E8A-4147-A177-3AD203B41FA5}">
                      <a16:colId xmlns:a16="http://schemas.microsoft.com/office/drawing/2014/main" val="895185105"/>
                    </a:ext>
                  </a:extLst>
                </a:gridCol>
                <a:gridCol w="739224">
                  <a:extLst>
                    <a:ext uri="{9D8B030D-6E8A-4147-A177-3AD203B41FA5}">
                      <a16:colId xmlns:a16="http://schemas.microsoft.com/office/drawing/2014/main" val="1214896209"/>
                    </a:ext>
                  </a:extLst>
                </a:gridCol>
              </a:tblGrid>
              <a:tr h="212552">
                <a:tc gridSpan="9">
                  <a:txBody>
                    <a:bodyPr/>
                    <a:lstStyle/>
                    <a:p>
                      <a:pPr marL="0" marR="0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 dirty="0">
                          <a:effectLst/>
                        </a:rPr>
                        <a:t> 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03377023"/>
                  </a:ext>
                </a:extLst>
              </a:tr>
              <a:tr h="212552">
                <a:tc rowSpan="2" gridSpan="3"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 dirty="0">
                          <a:effectLst/>
                        </a:rPr>
                        <a:t>District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marL="38100" marR="38100" algn="ct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 dirty="0">
                          <a:effectLst/>
                        </a:rPr>
                        <a:t>Year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38100" marR="38100" algn="ct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 dirty="0">
                          <a:effectLst/>
                        </a:rPr>
                        <a:t>Total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51100375"/>
                  </a:ext>
                </a:extLst>
              </a:tr>
              <a:tr h="212552">
                <a:tc gridSpan="3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38100" marR="38100" algn="ct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 dirty="0">
                          <a:effectLst/>
                        </a:rPr>
                        <a:t> 2013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ct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 dirty="0">
                          <a:effectLst/>
                        </a:rPr>
                        <a:t> 2014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ct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 dirty="0">
                          <a:effectLst/>
                        </a:rPr>
                        <a:t> 2015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ct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 dirty="0">
                          <a:effectLst/>
                        </a:rPr>
                        <a:t> 2016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ct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 dirty="0">
                          <a:effectLst/>
                        </a:rPr>
                        <a:t> 2017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27351725"/>
                  </a:ext>
                </a:extLst>
              </a:tr>
              <a:tr h="212552">
                <a:tc rowSpan="3"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Gombak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rowSpan="2"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Outbreak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NO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36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3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3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4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3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18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43706181"/>
                  </a:ext>
                </a:extLst>
              </a:tr>
              <a:tr h="22963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 dirty="0">
                          <a:effectLst/>
                        </a:rPr>
                        <a:t>YES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16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1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1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1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1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7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37440665"/>
                  </a:ext>
                </a:extLst>
              </a:tr>
              <a:tr h="21255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 dirty="0">
                          <a:effectLst/>
                        </a:rPr>
                        <a:t>Total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5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5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5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5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5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26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23560065"/>
                  </a:ext>
                </a:extLst>
              </a:tr>
              <a:tr h="212552">
                <a:tc rowSpan="3"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Hulu Langat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rowSpan="2"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Outbreak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NO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3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3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3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3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4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18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43823679"/>
                  </a:ext>
                </a:extLst>
              </a:tr>
              <a:tr h="22963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YES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19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19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1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1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1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79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716096310"/>
                  </a:ext>
                </a:extLst>
              </a:tr>
              <a:tr h="21255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 dirty="0">
                          <a:effectLst/>
                        </a:rPr>
                        <a:t>Total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5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5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5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5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5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26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94997133"/>
                  </a:ext>
                </a:extLst>
              </a:tr>
              <a:tr h="212552">
                <a:tc rowSpan="3"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Hulu Selangor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rowSpan="2"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Outbreak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NO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3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39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39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4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3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19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447281217"/>
                  </a:ext>
                </a:extLst>
              </a:tr>
              <a:tr h="22963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YES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1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1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1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1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1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66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652470088"/>
                  </a:ext>
                </a:extLst>
              </a:tr>
              <a:tr h="21255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Total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5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5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5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5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5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26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86700428"/>
                  </a:ext>
                </a:extLst>
              </a:tr>
              <a:tr h="212552">
                <a:tc rowSpan="3"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Klan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rowSpan="2"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Outbreak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NO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29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36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3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39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3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17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84710461"/>
                  </a:ext>
                </a:extLst>
              </a:tr>
              <a:tr h="22963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YES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2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16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1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1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1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8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049292034"/>
                  </a:ext>
                </a:extLst>
              </a:tr>
              <a:tr h="21255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Total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5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5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5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5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5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26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26232993"/>
                  </a:ext>
                </a:extLst>
              </a:tr>
              <a:tr h="212552">
                <a:tc rowSpan="3"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Petalin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rowSpan="2"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Outbreak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NO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3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3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4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4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4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19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366265116"/>
                  </a:ext>
                </a:extLst>
              </a:tr>
              <a:tr h="22963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YES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19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1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1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1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1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66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9652638"/>
                  </a:ext>
                </a:extLst>
              </a:tr>
              <a:tr h="21255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Total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5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5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5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5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5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26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99747192"/>
                  </a:ext>
                </a:extLst>
              </a:tr>
              <a:tr h="212552">
                <a:tc rowSpan="3"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Total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rowSpan="2"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Outbreak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NO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169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18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18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20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18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92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06263735"/>
                  </a:ext>
                </a:extLst>
              </a:tr>
              <a:tr h="22963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YES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9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7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7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6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7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37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38552098"/>
                  </a:ext>
                </a:extLst>
              </a:tr>
              <a:tr h="21255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Total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26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26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26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26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>
                          <a:effectLst/>
                        </a:rPr>
                        <a:t>26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38100" marR="38100" algn="r">
                        <a:lnSpc>
                          <a:spcPts val="16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MY" sz="1200" dirty="0">
                          <a:effectLst/>
                        </a:rPr>
                        <a:t>1300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2380515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8087721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2755786" y="219637"/>
            <a:ext cx="6384376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600" b="1" dirty="0" bmk="_Toc535433652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Table </a:t>
            </a:r>
            <a:r>
              <a:rPr kumimoji="0" lang="en-US" altLang="en-US" sz="1600" b="1" i="0" u="none" strike="noStrike" cap="none" normalizeH="0" baseline="0" dirty="0" bmk="_Toc535433652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. Summary</a:t>
            </a:r>
            <a:r>
              <a:rPr kumimoji="0" lang="en-US" altLang="en-US" sz="1600" b="1" i="0" u="none" strike="noStrike" cap="none" normalizeH="0" baseline="0" dirty="0" bmk="_Toc535433652">
                <a:ln>
                  <a:noFill/>
                </a:ln>
                <a:solidFill>
                  <a:srgbClr val="0070C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kumimoji="0" lang="en-US" altLang="en-US" sz="1600" b="1" i="0" u="none" strike="noStrike" cap="none" normalizeH="0" baseline="0" dirty="0" bmk="_Toc535433652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atistics for Climate Variables by Year</a:t>
            </a:r>
            <a:endParaRPr kumimoji="0" lang="en-US" altLang="en-US" sz="1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0" y="46101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6EF33AF3-DD15-433F-9B2C-E0C4161A96EE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2822100" y="609720"/>
          <a:ext cx="5637392" cy="6066917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409047">
                  <a:extLst>
                    <a:ext uri="{9D8B030D-6E8A-4147-A177-3AD203B41FA5}">
                      <a16:colId xmlns:a16="http://schemas.microsoft.com/office/drawing/2014/main" val="118949968"/>
                    </a:ext>
                  </a:extLst>
                </a:gridCol>
                <a:gridCol w="1593632">
                  <a:extLst>
                    <a:ext uri="{9D8B030D-6E8A-4147-A177-3AD203B41FA5}">
                      <a16:colId xmlns:a16="http://schemas.microsoft.com/office/drawing/2014/main" val="123224519"/>
                    </a:ext>
                  </a:extLst>
                </a:gridCol>
                <a:gridCol w="682858">
                  <a:extLst>
                    <a:ext uri="{9D8B030D-6E8A-4147-A177-3AD203B41FA5}">
                      <a16:colId xmlns:a16="http://schemas.microsoft.com/office/drawing/2014/main" val="571851548"/>
                    </a:ext>
                  </a:extLst>
                </a:gridCol>
                <a:gridCol w="1951855">
                  <a:extLst>
                    <a:ext uri="{9D8B030D-6E8A-4147-A177-3AD203B41FA5}">
                      <a16:colId xmlns:a16="http://schemas.microsoft.com/office/drawing/2014/main" val="3102123400"/>
                    </a:ext>
                  </a:extLst>
                </a:gridCol>
              </a:tblGrid>
              <a:tr h="140366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Year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riables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ndard deviation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2446203276"/>
                  </a:ext>
                </a:extLst>
              </a:tr>
              <a:tr h="140366">
                <a:tc rowSpan="6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3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Temperatur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6.78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1.14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1240400963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Maximum temperatur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7.76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1.19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2958387187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Minimum temperatur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5.65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1.22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1027438751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Humidity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81.42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4.97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4127860434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Rainfall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7.88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6.68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4213263169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Wind speed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.20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2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983091433"/>
                  </a:ext>
                </a:extLst>
              </a:tr>
              <a:tr h="140366">
                <a:tc rowSpan="6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14</a:t>
                      </a: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Temperatur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6.85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1.21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188184749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Maximum temperatur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7.81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1.25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3653133161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Minimum temperatur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5.80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1.30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3575541124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Humidity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79.68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7.01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3183191808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Rainfall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7.55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6.52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2900867721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Wind speed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.35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1.64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2624060913"/>
                  </a:ext>
                </a:extLst>
              </a:tr>
              <a:tr h="140366">
                <a:tc rowSpan="6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15</a:t>
                      </a: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Temperatur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7.02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1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1658508481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Maximum temperatur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7.97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1.23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2986296513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Minimum temperatur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6.01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1.12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2765380150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Humidity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80.60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6.06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4004343723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Rainfall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7.91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6.75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3463569719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Wind speed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3.07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3.04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3647289179"/>
                  </a:ext>
                </a:extLst>
              </a:tr>
              <a:tr h="140366">
                <a:tc rowSpan="6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16</a:t>
                      </a: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Temperatur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7.42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1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2065585854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Maximum temperatur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8.37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1.23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1507917111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Minimum temperatur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6.36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1.31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1005589649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Humidity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79.10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5.99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66830691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Rainfall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6.93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6.64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3629317344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Wind speed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1.96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1.30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414167879"/>
                  </a:ext>
                </a:extLst>
              </a:tr>
              <a:tr h="140366">
                <a:tc rowSpan="6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17</a:t>
                      </a: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Temperatur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6.77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1.06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264497851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Maximum temperatur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7.80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1.15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2854461429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Minimum temperatur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5.67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1.13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708970709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Humidity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81.79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5.59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3038889615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Rainfall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8.09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6.96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206437105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Wind speed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1.41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0.91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341546505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170089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A9BFAE9A-09FD-4180-8F35-CFCE4C5F99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86738" y="209715"/>
            <a:ext cx="6565452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T</a:t>
            </a:r>
            <a:r>
              <a:rPr kumimoji="0" lang="en-US" altLang="en-US" sz="1600" b="1" i="0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le 6. Summary Statistics for Climate Variable by District</a:t>
            </a:r>
            <a:endParaRPr kumimoji="0" lang="en-US" altLang="en-US" sz="1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9586CAC5-1543-4040-824E-B77301E643F8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2386738" y="652262"/>
          <a:ext cx="6090837" cy="6066917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522383">
                  <a:extLst>
                    <a:ext uri="{9D8B030D-6E8A-4147-A177-3AD203B41FA5}">
                      <a16:colId xmlns:a16="http://schemas.microsoft.com/office/drawing/2014/main" val="3849066806"/>
                    </a:ext>
                  </a:extLst>
                </a:gridCol>
                <a:gridCol w="2001549">
                  <a:extLst>
                    <a:ext uri="{9D8B030D-6E8A-4147-A177-3AD203B41FA5}">
                      <a16:colId xmlns:a16="http://schemas.microsoft.com/office/drawing/2014/main" val="3714883465"/>
                    </a:ext>
                  </a:extLst>
                </a:gridCol>
                <a:gridCol w="830907">
                  <a:extLst>
                    <a:ext uri="{9D8B030D-6E8A-4147-A177-3AD203B41FA5}">
                      <a16:colId xmlns:a16="http://schemas.microsoft.com/office/drawing/2014/main" val="838942472"/>
                    </a:ext>
                  </a:extLst>
                </a:gridCol>
                <a:gridCol w="1735998">
                  <a:extLst>
                    <a:ext uri="{9D8B030D-6E8A-4147-A177-3AD203B41FA5}">
                      <a16:colId xmlns:a16="http://schemas.microsoft.com/office/drawing/2014/main" val="4075595152"/>
                    </a:ext>
                  </a:extLst>
                </a:gridCol>
              </a:tblGrid>
              <a:tr h="140366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Year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riables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ndard deviation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624874034"/>
                  </a:ext>
                </a:extLst>
              </a:tr>
              <a:tr h="140366">
                <a:tc rowSpan="6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ombak</a:t>
                      </a: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Temperatur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6.49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0.79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1343310404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Maximum temperatur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7.50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0.87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2483938712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Minimum temperatur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5.92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0.91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1690408665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Humidity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5.36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4.83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143661471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Rainfall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84.69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5.06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1864270847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Wind speed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3.47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1.39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2026737685"/>
                  </a:ext>
                </a:extLst>
              </a:tr>
              <a:tr h="140366">
                <a:tc rowSpan="6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Hulu Langat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Temperatur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5.97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7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2029420705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Maximum temperatur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7.01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1.07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3358554359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Minimum temperatur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7.33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0.96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1392326668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Humidity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4.89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5.35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2141078988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Rainfall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80.98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6.45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1232582755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Wind speed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4.13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.92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1848815134"/>
                  </a:ext>
                </a:extLst>
              </a:tr>
              <a:tr h="140366">
                <a:tc rowSpan="6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Hulu Selangor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Temperatur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6.52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0.76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3177694063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Maximum temperatur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7.34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0.82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801840024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Minimum temperatur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8.72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0.89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138993295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Humidity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5.62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3.95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2514275179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Rainfall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84.47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7.27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137988270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Wind speed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0.74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0.10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1494781842"/>
                  </a:ext>
                </a:extLst>
              </a:tr>
              <a:tr h="140366">
                <a:tc rowSpan="6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US" sz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lang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Temperatur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7.73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0.85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88622435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Maximum temperatur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8.70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0.87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672030471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Minimum temperatur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8.16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1.02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207229573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Humidity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6.63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4.16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1399593307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Rainfall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75.32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7.32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1795795385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Wind speed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1.29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0.24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921363259"/>
                  </a:ext>
                </a:extLst>
              </a:tr>
              <a:tr h="140366">
                <a:tc rowSpan="6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US" sz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taling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Temperatur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8.11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0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1111544104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Maximum temperatur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9.12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0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2722944306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Minimum temperatur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8.24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1.03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1203668971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Humidity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26.97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5.22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2954283163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Rainfall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77.41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6.89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2935871224"/>
                  </a:ext>
                </a:extLst>
              </a:tr>
              <a:tr h="140366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Wind speed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1.62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0.27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46" marR="56146" marT="0" marB="0"/>
                </a:tc>
                <a:extLst>
                  <a:ext uri="{0D108BD9-81ED-4DB2-BD59-A6C34878D82A}">
                    <a16:rowId xmlns:a16="http://schemas.microsoft.com/office/drawing/2014/main" val="160033052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7932593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5">
            <a:extLst>
              <a:ext uri="{FF2B5EF4-FFF2-40B4-BE49-F238E27FC236}">
                <a16:creationId xmlns:a16="http://schemas.microsoft.com/office/drawing/2014/main" id="{4E8537A1-739F-4A1F-B599-F56673030DE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31309944"/>
              </p:ext>
            </p:extLst>
          </p:nvPr>
        </p:nvGraphicFramePr>
        <p:xfrm>
          <a:off x="488756" y="960700"/>
          <a:ext cx="10634134" cy="526576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317067">
                  <a:extLst>
                    <a:ext uri="{9D8B030D-6E8A-4147-A177-3AD203B41FA5}">
                      <a16:colId xmlns:a16="http://schemas.microsoft.com/office/drawing/2014/main" val="1833586537"/>
                    </a:ext>
                  </a:extLst>
                </a:gridCol>
                <a:gridCol w="5317067">
                  <a:extLst>
                    <a:ext uri="{9D8B030D-6E8A-4147-A177-3AD203B41FA5}">
                      <a16:colId xmlns:a16="http://schemas.microsoft.com/office/drawing/2014/main" val="2238420690"/>
                    </a:ext>
                  </a:extLst>
                </a:gridCol>
              </a:tblGrid>
              <a:tr h="438814"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r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breviation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6032199"/>
                  </a:ext>
                </a:extLst>
              </a:tr>
              <a:tr h="438814"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orld Health Organiza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HO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02785102"/>
                  </a:ext>
                </a:extLst>
              </a:tr>
              <a:tr h="438814"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ast Absolute Shrinkage Selection Operato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SSO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17870405"/>
                  </a:ext>
                </a:extLst>
              </a:tr>
              <a:tr h="438814"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pport Vector Regress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VR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0960455"/>
                  </a:ext>
                </a:extLst>
              </a:tr>
              <a:tr h="438814"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pport Vector Machi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VM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67694544"/>
                  </a:ext>
                </a:extLst>
              </a:tr>
              <a:tr h="438814"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utoregressive Integrated Moving Averag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IM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45694611"/>
                  </a:ext>
                </a:extLst>
              </a:tr>
              <a:tr h="438814"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ralized Additive Modeling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M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69496441"/>
                  </a:ext>
                </a:extLst>
              </a:tr>
              <a:tr h="438814"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imatological Mean of the Da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MD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65186123"/>
                  </a:ext>
                </a:extLst>
              </a:tr>
              <a:tr h="438814"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assification and Regression Tre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R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93167227"/>
                  </a:ext>
                </a:extLst>
              </a:tr>
              <a:tr h="438814"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tificial Neural Network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N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26482497"/>
                  </a:ext>
                </a:extLst>
              </a:tr>
              <a:tr h="438814"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e Augmented </a:t>
                      </a:r>
                      <a:r>
                        <a:rPr lang="en-US" sz="1600" b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aïve Bayes</a:t>
                      </a:r>
                      <a:endParaRPr lang="en-US" sz="16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N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08520402"/>
                  </a:ext>
                </a:extLst>
              </a:tr>
              <a:tr h="438814"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ceiver Operating Characteristic Curv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C Curv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546554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6E2064BD-25A3-472D-9F56-05541D97F8F6}"/>
              </a:ext>
            </a:extLst>
          </p:cNvPr>
          <p:cNvSpPr txBox="1"/>
          <p:nvPr/>
        </p:nvSpPr>
        <p:spPr>
          <a:xfrm>
            <a:off x="410556" y="510385"/>
            <a:ext cx="48678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7: Acronyms and Terminology</a:t>
            </a:r>
          </a:p>
        </p:txBody>
      </p:sp>
    </p:spTree>
    <p:extLst>
      <p:ext uri="{BB962C8B-B14F-4D97-AF65-F5344CB8AC3E}">
        <p14:creationId xmlns:p14="http://schemas.microsoft.com/office/powerpoint/2010/main" val="4429421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923</Words>
  <Application>Microsoft Office PowerPoint</Application>
  <PresentationFormat>Widescreen</PresentationFormat>
  <Paragraphs>497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THS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que, Md ubydul</dc:creator>
  <cp:lastModifiedBy>Haque, Md ubydul</cp:lastModifiedBy>
  <cp:revision>2</cp:revision>
  <dcterms:created xsi:type="dcterms:W3CDTF">2020-09-01T14:05:41Z</dcterms:created>
  <dcterms:modified xsi:type="dcterms:W3CDTF">2020-09-01T14:27:08Z</dcterms:modified>
</cp:coreProperties>
</file>